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17427BE-E5BC-4B4D-873A-ADC3A5F85276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35CD87C-3822-413B-95AC-D7E68D1E86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9805B0E-166D-4B9A-B85F-429DE050C4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6CF0570-11B9-4FD1-8E79-1AB636BD5EBC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44683FE-08A2-45F6-8DC7-4735D87C70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E459068-BD37-4D11-8B42-5C742F0B12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6BAE20A-F1B4-4102-9DCA-FE189A3E9B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FA98129-E3C4-4A3D-B310-7A82CC7E6B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0B3D42D-7D51-4FC9-BA42-72912B03B1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4E3211E-6B90-4975-A763-A37EA9A414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4C8F91C-F089-4E5F-81D8-05A2299286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CB095CC-9B8B-4EE5-AA5C-B1786F8EA4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24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25C5AB02-336F-4F8D-8368-54EC09B82E26}" type="slidenum">
              <a:rPr b="0" lang="en-US" sz="24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2680" y="517680"/>
          <a:ext cx="5945040" cy="2009520"/>
        </p:xfrm>
        <a:graphic>
          <a:graphicData uri="http://schemas.openxmlformats.org/drawingml/2006/table">
            <a:tbl>
              <a:tblPr/>
              <a:tblGrid>
                <a:gridCol w="658800"/>
                <a:gridCol w="658800"/>
                <a:gridCol w="676080"/>
                <a:gridCol w="658800"/>
                <a:gridCol w="657360"/>
                <a:gridCol w="658800"/>
                <a:gridCol w="658800"/>
                <a:gridCol w="658800"/>
                <a:gridCol w="658800"/>
              </a:tblGrid>
              <a:tr h="223560"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-GlcNA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MA - I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% B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D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bA1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O</a:t>
                      </a:r>
                      <a:r>
                        <a:rPr b="1" lang="en-US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2 pea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2248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-GlcNA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356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OMA - I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392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M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248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F 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356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D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392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bA1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248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O</a:t>
                      </a:r>
                      <a:r>
                        <a:rPr b="1" lang="en-US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1" lang="en-US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peak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3560">
                <a:tc>
                  <a:txBody>
                    <a:bodyPr lIns="36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 algn="ctr"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" rIns="9000" tIns="14760" bIns="0" anchor="ctr">
                      <a:noAutofit/>
                    </a:bodyPr>
                    <a:p>
                      <a:pPr>
                        <a:lnSpc>
                          <a:spcPct val="95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284040" y="2749680"/>
            <a:ext cx="6213600" cy="416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: Table S1.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elation table illustrating r values for the parameters assessed in this study. Abbreviations: percentage body fat (BF %); body mass index (BMI, kg</a:t>
            </a:r>
            <a:r>
              <a:rPr b="0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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r>
              <a:rPr b="0" lang="en-CA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2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; GlcNAcylatio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-GlcNAc, AU); glycated hemoglobin A1c (HbA1c, %)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;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 density lipoproteins (HDL, mM);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omeostatic model assessment for insulin resistance score (HOMA-IR, AU); aerobic capacity (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O</a:t>
            </a:r>
            <a:r>
              <a:rPr b="0" lang="en-CA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CA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peak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ml</a:t>
            </a:r>
            <a:r>
              <a:rPr b="0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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g</a:t>
            </a:r>
            <a:r>
              <a:rPr b="0" lang="en-CA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b="0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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n</a:t>
            </a:r>
            <a:r>
              <a:rPr b="0" lang="en-CA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1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triglycerides (TG, mM). The correlation coefficients were determined using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crosoft Excel:</a:t>
            </a:r>
            <a:r>
              <a:rPr b="0" lang="en-US" sz="1200" spc="-1" strike="noStrike">
                <a:solidFill>
                  <a:srgbClr val="ff3300"/>
                </a:solidFill>
                <a:latin typeface="Times New Roman"/>
                <a:ea typeface="Times New Roman"/>
              </a:rPr>
              <a:t>Ma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01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Version 14.4.2)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critical value of the Pearson Product-Moment Correlation Coefficient for a two tailed test at a significance level of 0.05 is &gt;0.43 (Galton, 1888)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0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15T22:03:50Z</dcterms:created>
  <dc:creator>Jason Myslicki</dc:creator>
  <dc:description/>
  <dc:language>en-US</dc:language>
  <cp:lastModifiedBy>Owner</cp:lastModifiedBy>
  <dcterms:modified xsi:type="dcterms:W3CDTF">2014-07-29T16:34:28Z</dcterms:modified>
  <cp:revision>69</cp:revision>
  <dc:subject/>
  <dc:title>PowerPoint Presentation</dc:title>
</cp:coreProperties>
</file>